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207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4B7623-63E7-487D-973E-53E6C372B7BE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1D87F-BB39-43FA-B991-5F9C768E80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33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51D87F-BB39-43FA-B991-5F9C768E80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110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76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38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64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539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26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20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3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941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64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98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2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4545844"/>
              </p:ext>
            </p:extLst>
          </p:nvPr>
        </p:nvGraphicFramePr>
        <p:xfrm>
          <a:off x="457200" y="1219200"/>
          <a:ext cx="4002088" cy="312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5" name="SPW 13.0 Graph" r:id="rId4" imgW="5781655" imgH="4514940" progId="SigmaPlotGraphicObject.12">
                  <p:embed/>
                </p:oleObj>
              </mc:Choice>
              <mc:Fallback>
                <p:oleObj name="SPW 13.0 Graph" r:id="rId4" imgW="5781655" imgH="4514940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7200" y="1219200"/>
                        <a:ext cx="4002088" cy="312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3181284"/>
              </p:ext>
            </p:extLst>
          </p:nvPr>
        </p:nvGraphicFramePr>
        <p:xfrm>
          <a:off x="4876800" y="1219200"/>
          <a:ext cx="4033838" cy="312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6" name="SPW 13.0 Graph" r:id="rId6" imgW="5829199" imgH="4514940" progId="SigmaPlotGraphicObject.12">
                  <p:embed/>
                </p:oleObj>
              </mc:Choice>
              <mc:Fallback>
                <p:oleObj name="SPW 13.0 Graph" r:id="rId6" imgW="5829199" imgH="4514940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76800" y="1219200"/>
                        <a:ext cx="4033838" cy="312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85800" y="1066800"/>
            <a:ext cx="13241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 Ceramide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953000" y="1009707"/>
            <a:ext cx="1745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Sphingomyelin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0200" y="4572000"/>
            <a:ext cx="7848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3 Fig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ffect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f diet and LPP3 expression on adipose tissue lipid composi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 Mice were f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at diet (HF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f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8 weeks, at which time white adipose tissue 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ed from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black symbols) 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2-Cre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Δ; open symbols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measurement of the indicated lipids by HPLC electrospray ionization tandem mass spectrometry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most abundant species of ceramides (A) and sphingomyelins (B) a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sented as mean ± S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 described in Figure 3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39374" y="1847654"/>
            <a:ext cx="49922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   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848600" y="1905000"/>
            <a:ext cx="49922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   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7673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100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SPW 13.0 Graph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7</cp:revision>
  <dcterms:created xsi:type="dcterms:W3CDTF">2017-09-11T17:11:52Z</dcterms:created>
  <dcterms:modified xsi:type="dcterms:W3CDTF">2018-05-31T16:38:03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